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449" r:id="rId2"/>
    <p:sldId id="454" r:id="rId3"/>
  </p:sldIdLst>
  <p:sldSz cx="7556500" cy="106918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660"/>
  </p:normalViewPr>
  <p:slideViewPr>
    <p:cSldViewPr snapToGrid="0">
      <p:cViewPr varScale="1">
        <p:scale>
          <a:sx n="75" d="100"/>
          <a:sy n="75" d="100"/>
        </p:scale>
        <p:origin x="2964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738" y="1749795"/>
            <a:ext cx="6423025" cy="3722335"/>
          </a:xfrm>
        </p:spPr>
        <p:txBody>
          <a:bodyPr anchor="b"/>
          <a:lstStyle>
            <a:lvl1pPr algn="ctr">
              <a:defRPr sz="4958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563" y="5615678"/>
            <a:ext cx="5667375" cy="2581379"/>
          </a:xfrm>
        </p:spPr>
        <p:txBody>
          <a:bodyPr/>
          <a:lstStyle>
            <a:lvl1pPr marL="0" indent="0" algn="ctr">
              <a:buNone/>
              <a:defRPr sz="1983"/>
            </a:lvl1pPr>
            <a:lvl2pPr marL="377830" indent="0" algn="ctr">
              <a:buNone/>
              <a:defRPr sz="1653"/>
            </a:lvl2pPr>
            <a:lvl3pPr marL="755660" indent="0" algn="ctr">
              <a:buNone/>
              <a:defRPr sz="1488"/>
            </a:lvl3pPr>
            <a:lvl4pPr marL="1133490" indent="0" algn="ctr">
              <a:buNone/>
              <a:defRPr sz="1322"/>
            </a:lvl4pPr>
            <a:lvl5pPr marL="1511320" indent="0" algn="ctr">
              <a:buNone/>
              <a:defRPr sz="1322"/>
            </a:lvl5pPr>
            <a:lvl6pPr marL="1889150" indent="0" algn="ctr">
              <a:buNone/>
              <a:defRPr sz="1322"/>
            </a:lvl6pPr>
            <a:lvl7pPr marL="2266980" indent="0" algn="ctr">
              <a:buNone/>
              <a:defRPr sz="1322"/>
            </a:lvl7pPr>
            <a:lvl8pPr marL="2644811" indent="0" algn="ctr">
              <a:buNone/>
              <a:defRPr sz="1322"/>
            </a:lvl8pPr>
            <a:lvl9pPr marL="3022641" indent="0" algn="ctr">
              <a:buNone/>
              <a:defRPr sz="1322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1CF485-9C34-4995-8BBB-F7C55E26BD58}" type="datetimeFigureOut">
              <a:rPr lang="en-IN" smtClean="0"/>
              <a:t>05-08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EAA41-23BD-46EF-AA32-BA9BC9F293F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393860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1CF485-9C34-4995-8BBB-F7C55E26BD58}" type="datetimeFigureOut">
              <a:rPr lang="en-IN" smtClean="0"/>
              <a:t>05-08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EAA41-23BD-46EF-AA32-BA9BC9F293F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9791223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7621" y="569240"/>
            <a:ext cx="1629370" cy="90608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510" y="569240"/>
            <a:ext cx="4793655" cy="90608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1CF485-9C34-4995-8BBB-F7C55E26BD58}" type="datetimeFigureOut">
              <a:rPr lang="en-IN" smtClean="0"/>
              <a:t>05-08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EAA41-23BD-46EF-AA32-BA9BC9F293F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2472333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1CF485-9C34-4995-8BBB-F7C55E26BD58}" type="datetimeFigureOut">
              <a:rPr lang="en-IN" smtClean="0"/>
              <a:t>05-08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EAA41-23BD-46EF-AA32-BA9BC9F293F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9287884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574" y="2665532"/>
            <a:ext cx="6517481" cy="4447496"/>
          </a:xfrm>
        </p:spPr>
        <p:txBody>
          <a:bodyPr anchor="b"/>
          <a:lstStyle>
            <a:lvl1pPr>
              <a:defRPr sz="4958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574" y="7155103"/>
            <a:ext cx="6517481" cy="2338833"/>
          </a:xfrm>
        </p:spPr>
        <p:txBody>
          <a:bodyPr/>
          <a:lstStyle>
            <a:lvl1pPr marL="0" indent="0">
              <a:buNone/>
              <a:defRPr sz="1983">
                <a:solidFill>
                  <a:schemeClr val="tx1"/>
                </a:solidFill>
              </a:defRPr>
            </a:lvl1pPr>
            <a:lvl2pPr marL="377830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660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490" indent="0">
              <a:buNone/>
              <a:defRPr sz="1322">
                <a:solidFill>
                  <a:schemeClr val="tx1">
                    <a:tint val="75000"/>
                  </a:schemeClr>
                </a:solidFill>
              </a:defRPr>
            </a:lvl4pPr>
            <a:lvl5pPr marL="1511320" indent="0">
              <a:buNone/>
              <a:defRPr sz="1322">
                <a:solidFill>
                  <a:schemeClr val="tx1">
                    <a:tint val="75000"/>
                  </a:schemeClr>
                </a:solidFill>
              </a:defRPr>
            </a:lvl5pPr>
            <a:lvl6pPr marL="1889150" indent="0">
              <a:buNone/>
              <a:defRPr sz="1322">
                <a:solidFill>
                  <a:schemeClr val="tx1">
                    <a:tint val="75000"/>
                  </a:schemeClr>
                </a:solidFill>
              </a:defRPr>
            </a:lvl6pPr>
            <a:lvl7pPr marL="2266980" indent="0">
              <a:buNone/>
              <a:defRPr sz="1322">
                <a:solidFill>
                  <a:schemeClr val="tx1">
                    <a:tint val="75000"/>
                  </a:schemeClr>
                </a:solidFill>
              </a:defRPr>
            </a:lvl7pPr>
            <a:lvl8pPr marL="2644811" indent="0">
              <a:buNone/>
              <a:defRPr sz="1322">
                <a:solidFill>
                  <a:schemeClr val="tx1">
                    <a:tint val="75000"/>
                  </a:schemeClr>
                </a:solidFill>
              </a:defRPr>
            </a:lvl8pPr>
            <a:lvl9pPr marL="3022641" indent="0">
              <a:buNone/>
              <a:defRPr sz="1322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1CF485-9C34-4995-8BBB-F7C55E26BD58}" type="datetimeFigureOut">
              <a:rPr lang="en-IN" smtClean="0"/>
              <a:t>05-08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EAA41-23BD-46EF-AA32-BA9BC9F293F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2409432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509" y="2846200"/>
            <a:ext cx="3211513" cy="678385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5478" y="2846200"/>
            <a:ext cx="3211513" cy="678385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1CF485-9C34-4995-8BBB-F7C55E26BD58}" type="datetimeFigureOut">
              <a:rPr lang="en-IN" smtClean="0"/>
              <a:t>05-08-2024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EAA41-23BD-46EF-AA32-BA9BC9F293F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6007250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494" y="569242"/>
            <a:ext cx="6517481" cy="2066590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495" y="2620980"/>
            <a:ext cx="3196753" cy="1284502"/>
          </a:xfrm>
        </p:spPr>
        <p:txBody>
          <a:bodyPr anchor="b"/>
          <a:lstStyle>
            <a:lvl1pPr marL="0" indent="0">
              <a:buNone/>
              <a:defRPr sz="1983" b="1"/>
            </a:lvl1pPr>
            <a:lvl2pPr marL="377830" indent="0">
              <a:buNone/>
              <a:defRPr sz="1653" b="1"/>
            </a:lvl2pPr>
            <a:lvl3pPr marL="755660" indent="0">
              <a:buNone/>
              <a:defRPr sz="1488" b="1"/>
            </a:lvl3pPr>
            <a:lvl4pPr marL="1133490" indent="0">
              <a:buNone/>
              <a:defRPr sz="1322" b="1"/>
            </a:lvl4pPr>
            <a:lvl5pPr marL="1511320" indent="0">
              <a:buNone/>
              <a:defRPr sz="1322" b="1"/>
            </a:lvl5pPr>
            <a:lvl6pPr marL="1889150" indent="0">
              <a:buNone/>
              <a:defRPr sz="1322" b="1"/>
            </a:lvl6pPr>
            <a:lvl7pPr marL="2266980" indent="0">
              <a:buNone/>
              <a:defRPr sz="1322" b="1"/>
            </a:lvl7pPr>
            <a:lvl8pPr marL="2644811" indent="0">
              <a:buNone/>
              <a:defRPr sz="1322" b="1"/>
            </a:lvl8pPr>
            <a:lvl9pPr marL="3022641" indent="0">
              <a:buNone/>
              <a:defRPr sz="1322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495" y="3905482"/>
            <a:ext cx="3196753" cy="574437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5478" y="2620980"/>
            <a:ext cx="3212497" cy="1284502"/>
          </a:xfrm>
        </p:spPr>
        <p:txBody>
          <a:bodyPr anchor="b"/>
          <a:lstStyle>
            <a:lvl1pPr marL="0" indent="0">
              <a:buNone/>
              <a:defRPr sz="1983" b="1"/>
            </a:lvl1pPr>
            <a:lvl2pPr marL="377830" indent="0">
              <a:buNone/>
              <a:defRPr sz="1653" b="1"/>
            </a:lvl2pPr>
            <a:lvl3pPr marL="755660" indent="0">
              <a:buNone/>
              <a:defRPr sz="1488" b="1"/>
            </a:lvl3pPr>
            <a:lvl4pPr marL="1133490" indent="0">
              <a:buNone/>
              <a:defRPr sz="1322" b="1"/>
            </a:lvl4pPr>
            <a:lvl5pPr marL="1511320" indent="0">
              <a:buNone/>
              <a:defRPr sz="1322" b="1"/>
            </a:lvl5pPr>
            <a:lvl6pPr marL="1889150" indent="0">
              <a:buNone/>
              <a:defRPr sz="1322" b="1"/>
            </a:lvl6pPr>
            <a:lvl7pPr marL="2266980" indent="0">
              <a:buNone/>
              <a:defRPr sz="1322" b="1"/>
            </a:lvl7pPr>
            <a:lvl8pPr marL="2644811" indent="0">
              <a:buNone/>
              <a:defRPr sz="1322" b="1"/>
            </a:lvl8pPr>
            <a:lvl9pPr marL="3022641" indent="0">
              <a:buNone/>
              <a:defRPr sz="1322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5478" y="3905482"/>
            <a:ext cx="3212497" cy="574437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1CF485-9C34-4995-8BBB-F7C55E26BD58}" type="datetimeFigureOut">
              <a:rPr lang="en-IN" smtClean="0"/>
              <a:t>05-08-2024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EAA41-23BD-46EF-AA32-BA9BC9F293F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6399245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1CF485-9C34-4995-8BBB-F7C55E26BD58}" type="datetimeFigureOut">
              <a:rPr lang="en-IN" smtClean="0"/>
              <a:t>05-08-2024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EAA41-23BD-46EF-AA32-BA9BC9F293F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5783186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1CF485-9C34-4995-8BBB-F7C55E26BD58}" type="datetimeFigureOut">
              <a:rPr lang="en-IN" smtClean="0"/>
              <a:t>05-08-2024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EAA41-23BD-46EF-AA32-BA9BC9F293F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9097710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494" y="712788"/>
            <a:ext cx="2437168" cy="2494756"/>
          </a:xfrm>
        </p:spPr>
        <p:txBody>
          <a:bodyPr anchor="b"/>
          <a:lstStyle>
            <a:lvl1pPr>
              <a:defRPr sz="264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2497" y="1539425"/>
            <a:ext cx="3825478" cy="7598117"/>
          </a:xfrm>
        </p:spPr>
        <p:txBody>
          <a:bodyPr/>
          <a:lstStyle>
            <a:lvl1pPr>
              <a:defRPr sz="2644"/>
            </a:lvl1pPr>
            <a:lvl2pPr>
              <a:defRPr sz="2314"/>
            </a:lvl2pPr>
            <a:lvl3pPr>
              <a:defRPr sz="1983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494" y="3207544"/>
            <a:ext cx="2437168" cy="5942372"/>
          </a:xfrm>
        </p:spPr>
        <p:txBody>
          <a:bodyPr/>
          <a:lstStyle>
            <a:lvl1pPr marL="0" indent="0">
              <a:buNone/>
              <a:defRPr sz="1322"/>
            </a:lvl1pPr>
            <a:lvl2pPr marL="377830" indent="0">
              <a:buNone/>
              <a:defRPr sz="1157"/>
            </a:lvl2pPr>
            <a:lvl3pPr marL="755660" indent="0">
              <a:buNone/>
              <a:defRPr sz="992"/>
            </a:lvl3pPr>
            <a:lvl4pPr marL="1133490" indent="0">
              <a:buNone/>
              <a:defRPr sz="826"/>
            </a:lvl4pPr>
            <a:lvl5pPr marL="1511320" indent="0">
              <a:buNone/>
              <a:defRPr sz="826"/>
            </a:lvl5pPr>
            <a:lvl6pPr marL="1889150" indent="0">
              <a:buNone/>
              <a:defRPr sz="826"/>
            </a:lvl6pPr>
            <a:lvl7pPr marL="2266980" indent="0">
              <a:buNone/>
              <a:defRPr sz="826"/>
            </a:lvl7pPr>
            <a:lvl8pPr marL="2644811" indent="0">
              <a:buNone/>
              <a:defRPr sz="826"/>
            </a:lvl8pPr>
            <a:lvl9pPr marL="3022641" indent="0">
              <a:buNone/>
              <a:defRPr sz="826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1CF485-9C34-4995-8BBB-F7C55E26BD58}" type="datetimeFigureOut">
              <a:rPr lang="en-IN" smtClean="0"/>
              <a:t>05-08-2024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EAA41-23BD-46EF-AA32-BA9BC9F293F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7257947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494" y="712788"/>
            <a:ext cx="2437168" cy="2494756"/>
          </a:xfrm>
        </p:spPr>
        <p:txBody>
          <a:bodyPr anchor="b"/>
          <a:lstStyle>
            <a:lvl1pPr>
              <a:defRPr sz="264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2497" y="1539425"/>
            <a:ext cx="3825478" cy="7598117"/>
          </a:xfrm>
        </p:spPr>
        <p:txBody>
          <a:bodyPr anchor="t"/>
          <a:lstStyle>
            <a:lvl1pPr marL="0" indent="0">
              <a:buNone/>
              <a:defRPr sz="2644"/>
            </a:lvl1pPr>
            <a:lvl2pPr marL="377830" indent="0">
              <a:buNone/>
              <a:defRPr sz="2314"/>
            </a:lvl2pPr>
            <a:lvl3pPr marL="755660" indent="0">
              <a:buNone/>
              <a:defRPr sz="1983"/>
            </a:lvl3pPr>
            <a:lvl4pPr marL="1133490" indent="0">
              <a:buNone/>
              <a:defRPr sz="1653"/>
            </a:lvl4pPr>
            <a:lvl5pPr marL="1511320" indent="0">
              <a:buNone/>
              <a:defRPr sz="1653"/>
            </a:lvl5pPr>
            <a:lvl6pPr marL="1889150" indent="0">
              <a:buNone/>
              <a:defRPr sz="1653"/>
            </a:lvl6pPr>
            <a:lvl7pPr marL="2266980" indent="0">
              <a:buNone/>
              <a:defRPr sz="1653"/>
            </a:lvl7pPr>
            <a:lvl8pPr marL="2644811" indent="0">
              <a:buNone/>
              <a:defRPr sz="1653"/>
            </a:lvl8pPr>
            <a:lvl9pPr marL="3022641" indent="0">
              <a:buNone/>
              <a:defRPr sz="1653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494" y="3207544"/>
            <a:ext cx="2437168" cy="5942372"/>
          </a:xfrm>
        </p:spPr>
        <p:txBody>
          <a:bodyPr/>
          <a:lstStyle>
            <a:lvl1pPr marL="0" indent="0">
              <a:buNone/>
              <a:defRPr sz="1322"/>
            </a:lvl1pPr>
            <a:lvl2pPr marL="377830" indent="0">
              <a:buNone/>
              <a:defRPr sz="1157"/>
            </a:lvl2pPr>
            <a:lvl3pPr marL="755660" indent="0">
              <a:buNone/>
              <a:defRPr sz="992"/>
            </a:lvl3pPr>
            <a:lvl4pPr marL="1133490" indent="0">
              <a:buNone/>
              <a:defRPr sz="826"/>
            </a:lvl4pPr>
            <a:lvl5pPr marL="1511320" indent="0">
              <a:buNone/>
              <a:defRPr sz="826"/>
            </a:lvl5pPr>
            <a:lvl6pPr marL="1889150" indent="0">
              <a:buNone/>
              <a:defRPr sz="826"/>
            </a:lvl6pPr>
            <a:lvl7pPr marL="2266980" indent="0">
              <a:buNone/>
              <a:defRPr sz="826"/>
            </a:lvl7pPr>
            <a:lvl8pPr marL="2644811" indent="0">
              <a:buNone/>
              <a:defRPr sz="826"/>
            </a:lvl8pPr>
            <a:lvl9pPr marL="3022641" indent="0">
              <a:buNone/>
              <a:defRPr sz="826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1CF485-9C34-4995-8BBB-F7C55E26BD58}" type="datetimeFigureOut">
              <a:rPr lang="en-IN" smtClean="0"/>
              <a:t>05-08-2024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EAA41-23BD-46EF-AA32-BA9BC9F293F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3444367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510" y="569242"/>
            <a:ext cx="6517481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510" y="2846200"/>
            <a:ext cx="6517481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509" y="9909729"/>
            <a:ext cx="1700213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1CF485-9C34-4995-8BBB-F7C55E26BD58}" type="datetimeFigureOut">
              <a:rPr lang="en-IN" smtClean="0"/>
              <a:t>05-08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3091" y="9909729"/>
            <a:ext cx="2550319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6778" y="9909729"/>
            <a:ext cx="1700213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9EAA41-23BD-46EF-AA32-BA9BC9F293F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1268730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55660" rtl="0" eaLnBrk="1" latinLnBrk="0" hangingPunct="1">
        <a:lnSpc>
          <a:spcPct val="90000"/>
        </a:lnSpc>
        <a:spcBef>
          <a:spcPct val="0"/>
        </a:spcBef>
        <a:buNone/>
        <a:defRPr sz="3636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15" indent="-188915" algn="l" defTabSz="755660" rtl="0" eaLnBrk="1" latinLnBrk="0" hangingPunct="1">
        <a:lnSpc>
          <a:spcPct val="90000"/>
        </a:lnSpc>
        <a:spcBef>
          <a:spcPts val="826"/>
        </a:spcBef>
        <a:buFont typeface="Arial" panose="020B0604020202020204" pitchFamily="34" charset="0"/>
        <a:buChar char="•"/>
        <a:defRPr sz="2314" kern="1200">
          <a:solidFill>
            <a:schemeClr val="tx1"/>
          </a:solidFill>
          <a:latin typeface="+mn-lt"/>
          <a:ea typeface="+mn-ea"/>
          <a:cs typeface="+mn-cs"/>
        </a:defRPr>
      </a:lvl1pPr>
      <a:lvl2pPr marL="566745" indent="-188915" algn="l" defTabSz="755660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3" kern="1200">
          <a:solidFill>
            <a:schemeClr val="tx1"/>
          </a:solidFill>
          <a:latin typeface="+mn-lt"/>
          <a:ea typeface="+mn-ea"/>
          <a:cs typeface="+mn-cs"/>
        </a:defRPr>
      </a:lvl2pPr>
      <a:lvl3pPr marL="944575" indent="-188915" algn="l" defTabSz="755660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405" indent="-188915" algn="l" defTabSz="755660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235" indent="-188915" algn="l" defTabSz="755660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065" indent="-188915" algn="l" defTabSz="755660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5896" indent="-188915" algn="l" defTabSz="755660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3726" indent="-188915" algn="l" defTabSz="755660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1556" indent="-188915" algn="l" defTabSz="755660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660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830" algn="l" defTabSz="755660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660" algn="l" defTabSz="755660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490" algn="l" defTabSz="755660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320" algn="l" defTabSz="755660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150" algn="l" defTabSz="755660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6980" algn="l" defTabSz="755660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4811" algn="l" defTabSz="755660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2641" algn="l" defTabSz="755660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E743D66D-894F-01C8-7736-17603C428755}"/>
              </a:ext>
            </a:extLst>
          </p:cNvPr>
          <p:cNvGraphicFramePr>
            <a:graphicFrameLocks noGrp="1"/>
          </p:cNvGraphicFramePr>
          <p:nvPr/>
        </p:nvGraphicFramePr>
        <p:xfrm>
          <a:off x="291453" y="3589426"/>
          <a:ext cx="6385510" cy="4003023"/>
        </p:xfrm>
        <a:graphic>
          <a:graphicData uri="http://schemas.openxmlformats.org/drawingml/2006/table">
            <a:tbl>
              <a:tblPr firstRow="1" bandRow="1">
                <a:tableStyleId>{21E4AEA4-8DFA-4A89-87EB-49C32662AFE0}</a:tableStyleId>
              </a:tblPr>
              <a:tblGrid>
                <a:gridCol w="890820">
                  <a:extLst>
                    <a:ext uri="{9D8B030D-6E8A-4147-A177-3AD203B41FA5}">
                      <a16:colId xmlns:a16="http://schemas.microsoft.com/office/drawing/2014/main" val="2367951046"/>
                    </a:ext>
                  </a:extLst>
                </a:gridCol>
                <a:gridCol w="997542">
                  <a:extLst>
                    <a:ext uri="{9D8B030D-6E8A-4147-A177-3AD203B41FA5}">
                      <a16:colId xmlns:a16="http://schemas.microsoft.com/office/drawing/2014/main" val="1919467383"/>
                    </a:ext>
                  </a:extLst>
                </a:gridCol>
                <a:gridCol w="870416">
                  <a:extLst>
                    <a:ext uri="{9D8B030D-6E8A-4147-A177-3AD203B41FA5}">
                      <a16:colId xmlns:a16="http://schemas.microsoft.com/office/drawing/2014/main" val="3424278642"/>
                    </a:ext>
                  </a:extLst>
                </a:gridCol>
                <a:gridCol w="962733">
                  <a:extLst>
                    <a:ext uri="{9D8B030D-6E8A-4147-A177-3AD203B41FA5}">
                      <a16:colId xmlns:a16="http://schemas.microsoft.com/office/drawing/2014/main" val="974041692"/>
                    </a:ext>
                  </a:extLst>
                </a:gridCol>
                <a:gridCol w="764911">
                  <a:extLst>
                    <a:ext uri="{9D8B030D-6E8A-4147-A177-3AD203B41FA5}">
                      <a16:colId xmlns:a16="http://schemas.microsoft.com/office/drawing/2014/main" val="1095626669"/>
                    </a:ext>
                  </a:extLst>
                </a:gridCol>
                <a:gridCol w="949544">
                  <a:extLst>
                    <a:ext uri="{9D8B030D-6E8A-4147-A177-3AD203B41FA5}">
                      <a16:colId xmlns:a16="http://schemas.microsoft.com/office/drawing/2014/main" val="2173036929"/>
                    </a:ext>
                  </a:extLst>
                </a:gridCol>
                <a:gridCol w="949544">
                  <a:extLst>
                    <a:ext uri="{9D8B030D-6E8A-4147-A177-3AD203B41FA5}">
                      <a16:colId xmlns:a16="http://schemas.microsoft.com/office/drawing/2014/main" val="3226020662"/>
                    </a:ext>
                  </a:extLst>
                </a:gridCol>
              </a:tblGrid>
              <a:tr h="373223"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 ID</a:t>
                      </a:r>
                      <a:endParaRPr lang="en-I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17" marR="7617" marT="761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soelectric point</a:t>
                      </a:r>
                    </a:p>
                  </a:txBody>
                  <a:tcPr marL="7617" marR="7617" marT="761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stability index</a:t>
                      </a:r>
                    </a:p>
                  </a:txBody>
                  <a:tcPr marL="7617" marR="7617" marT="761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liphatic index</a:t>
                      </a:r>
                    </a:p>
                  </a:txBody>
                  <a:tcPr marL="7617" marR="7617" marT="761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RAVY</a:t>
                      </a:r>
                    </a:p>
                  </a:txBody>
                  <a:tcPr marL="7617" marR="7617" marT="761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bcellular localization</a:t>
                      </a:r>
                    </a:p>
                  </a:txBody>
                  <a:tcPr marL="7617" marR="7617" marT="761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glycosylation site</a:t>
                      </a:r>
                      <a:endParaRPr lang="en-IN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17" marR="7617" marT="7617" marB="0" anchor="ctr"/>
                </a:tc>
                <a:extLst>
                  <a:ext uri="{0D108BD9-81ED-4DB2-BD59-A6C34878D82A}">
                    <a16:rowId xmlns:a16="http://schemas.microsoft.com/office/drawing/2014/main" val="627698021"/>
                  </a:ext>
                </a:extLst>
              </a:tr>
              <a:tr h="317499"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CKX5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08</a:t>
                      </a:r>
                    </a:p>
                  </a:txBody>
                  <a:tcPr marL="7617" marR="7617" marT="761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2.13</a:t>
                      </a:r>
                    </a:p>
                  </a:txBody>
                  <a:tcPr marL="7617" marR="7617" marT="761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9.87</a:t>
                      </a:r>
                    </a:p>
                  </a:txBody>
                  <a:tcPr marL="7617" marR="7617" marT="761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197</a:t>
                      </a:r>
                    </a:p>
                  </a:txBody>
                  <a:tcPr marL="7617" marR="7617" marT="761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toplasm</a:t>
                      </a:r>
                    </a:p>
                  </a:txBody>
                  <a:tcPr marL="7617" marR="7617" marT="761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7617" marR="7617" marT="7617" marB="0" anchor="ctr"/>
                </a:tc>
                <a:extLst>
                  <a:ext uri="{0D108BD9-81ED-4DB2-BD59-A6C34878D82A}">
                    <a16:rowId xmlns:a16="http://schemas.microsoft.com/office/drawing/2014/main" val="132377254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CKX7.A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51</a:t>
                      </a:r>
                    </a:p>
                  </a:txBody>
                  <a:tcPr marL="7617" marR="7617" marT="761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7.58</a:t>
                      </a:r>
                    </a:p>
                  </a:txBody>
                  <a:tcPr marL="7617" marR="7617" marT="761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3.01</a:t>
                      </a:r>
                    </a:p>
                  </a:txBody>
                  <a:tcPr marL="7617" marR="7617" marT="761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28</a:t>
                      </a:r>
                    </a:p>
                  </a:txBody>
                  <a:tcPr marL="7617" marR="7617" marT="761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loroplast</a:t>
                      </a:r>
                    </a:p>
                  </a:txBody>
                  <a:tcPr marL="7617" marR="7617" marT="761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</a:p>
                  </a:txBody>
                  <a:tcPr marL="7617" marR="7617" marT="7617" marB="0" anchor="ctr"/>
                </a:tc>
                <a:extLst>
                  <a:ext uri="{0D108BD9-81ED-4DB2-BD59-A6C34878D82A}">
                    <a16:rowId xmlns:a16="http://schemas.microsoft.com/office/drawing/2014/main" val="2401070365"/>
                  </a:ext>
                </a:extLst>
              </a:tr>
              <a:tr h="317499"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CKX7.B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51</a:t>
                      </a:r>
                    </a:p>
                  </a:txBody>
                  <a:tcPr marL="7617" marR="7617" marT="761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7.83</a:t>
                      </a:r>
                    </a:p>
                  </a:txBody>
                  <a:tcPr marL="7617" marR="7617" marT="761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3.4</a:t>
                      </a:r>
                    </a:p>
                  </a:txBody>
                  <a:tcPr marL="7617" marR="7617" marT="761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271</a:t>
                      </a:r>
                    </a:p>
                  </a:txBody>
                  <a:tcPr marL="7617" marR="7617" marT="761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loroplast</a:t>
                      </a:r>
                    </a:p>
                  </a:txBody>
                  <a:tcPr marL="7617" marR="7617" marT="761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</a:p>
                  </a:txBody>
                  <a:tcPr marL="7617" marR="7617" marT="7617" marB="0" anchor="ctr"/>
                </a:tc>
                <a:extLst>
                  <a:ext uri="{0D108BD9-81ED-4DB2-BD59-A6C34878D82A}">
                    <a16:rowId xmlns:a16="http://schemas.microsoft.com/office/drawing/2014/main" val="1501735269"/>
                  </a:ext>
                </a:extLst>
              </a:tr>
              <a:tr h="317499"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CKX6.A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22</a:t>
                      </a:r>
                    </a:p>
                  </a:txBody>
                  <a:tcPr marL="7617" marR="7617" marT="761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76</a:t>
                      </a:r>
                    </a:p>
                  </a:txBody>
                  <a:tcPr marL="7617" marR="7617" marT="761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5.41</a:t>
                      </a:r>
                    </a:p>
                  </a:txBody>
                  <a:tcPr marL="7617" marR="7617" marT="761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106</a:t>
                      </a:r>
                    </a:p>
                  </a:txBody>
                  <a:tcPr marL="7617" marR="7617" marT="761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lasma membrane; Vacuole</a:t>
                      </a:r>
                    </a:p>
                  </a:txBody>
                  <a:tcPr marL="7617" marR="7617" marT="761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</a:p>
                  </a:txBody>
                  <a:tcPr marL="7617" marR="7617" marT="7617" marB="0" anchor="ctr"/>
                </a:tc>
                <a:extLst>
                  <a:ext uri="{0D108BD9-81ED-4DB2-BD59-A6C34878D82A}">
                    <a16:rowId xmlns:a16="http://schemas.microsoft.com/office/drawing/2014/main" val="2428330836"/>
                  </a:ext>
                </a:extLst>
              </a:tr>
              <a:tr h="317499"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CKX6.B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47</a:t>
                      </a:r>
                    </a:p>
                  </a:txBody>
                  <a:tcPr marL="7617" marR="7617" marT="761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.77</a:t>
                      </a:r>
                    </a:p>
                  </a:txBody>
                  <a:tcPr marL="7617" marR="7617" marT="761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3.92</a:t>
                      </a:r>
                    </a:p>
                  </a:txBody>
                  <a:tcPr marL="7617" marR="7617" marT="761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15</a:t>
                      </a:r>
                    </a:p>
                  </a:txBody>
                  <a:tcPr marL="7617" marR="7617" marT="7617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75566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lasma membrane; Vacuole</a:t>
                      </a:r>
                    </a:p>
                    <a:p>
                      <a:pPr algn="ctr" fontAlgn="b"/>
                      <a:endParaRPr lang="en-I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17" marR="7617" marT="761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</a:p>
                  </a:txBody>
                  <a:tcPr marL="7617" marR="7617" marT="7617" marB="0" anchor="ctr"/>
                </a:tc>
                <a:extLst>
                  <a:ext uri="{0D108BD9-81ED-4DB2-BD59-A6C34878D82A}">
                    <a16:rowId xmlns:a16="http://schemas.microsoft.com/office/drawing/2014/main" val="3182507481"/>
                  </a:ext>
                </a:extLst>
              </a:tr>
              <a:tr h="317499"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CKX3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71</a:t>
                      </a:r>
                    </a:p>
                  </a:txBody>
                  <a:tcPr marL="7617" marR="7617" marT="761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4.25</a:t>
                      </a:r>
                    </a:p>
                  </a:txBody>
                  <a:tcPr marL="7617" marR="7617" marT="761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1.72</a:t>
                      </a:r>
                    </a:p>
                  </a:txBody>
                  <a:tcPr marL="7617" marR="7617" marT="761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164</a:t>
                      </a:r>
                    </a:p>
                  </a:txBody>
                  <a:tcPr marL="7617" marR="7617" marT="761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loroplast</a:t>
                      </a:r>
                    </a:p>
                  </a:txBody>
                  <a:tcPr marL="7617" marR="7617" marT="761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7617" marR="7617" marT="7617" marB="0" anchor="ctr"/>
                </a:tc>
                <a:extLst>
                  <a:ext uri="{0D108BD9-81ED-4DB2-BD59-A6C34878D82A}">
                    <a16:rowId xmlns:a16="http://schemas.microsoft.com/office/drawing/2014/main" val="2995549600"/>
                  </a:ext>
                </a:extLst>
              </a:tr>
              <a:tr h="317499"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CKX4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09</a:t>
                      </a:r>
                    </a:p>
                  </a:txBody>
                  <a:tcPr marL="7617" marR="7617" marT="761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6.42</a:t>
                      </a:r>
                    </a:p>
                  </a:txBody>
                  <a:tcPr marL="7617" marR="7617" marT="761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9.08</a:t>
                      </a:r>
                    </a:p>
                  </a:txBody>
                  <a:tcPr marL="7617" marR="7617" marT="761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255</a:t>
                      </a:r>
                    </a:p>
                  </a:txBody>
                  <a:tcPr marL="7617" marR="7617" marT="761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lasma membrane</a:t>
                      </a:r>
                    </a:p>
                  </a:txBody>
                  <a:tcPr marL="7617" marR="7617" marT="761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</a:p>
                  </a:txBody>
                  <a:tcPr marL="7617" marR="7617" marT="7617" marB="0" anchor="ctr"/>
                </a:tc>
                <a:extLst>
                  <a:ext uri="{0D108BD9-81ED-4DB2-BD59-A6C34878D82A}">
                    <a16:rowId xmlns:a16="http://schemas.microsoft.com/office/drawing/2014/main" val="3853964692"/>
                  </a:ext>
                </a:extLst>
              </a:tr>
              <a:tr h="317499"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CKX1.A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53</a:t>
                      </a:r>
                    </a:p>
                  </a:txBody>
                  <a:tcPr marL="7617" marR="7617" marT="761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8.14</a:t>
                      </a:r>
                    </a:p>
                  </a:txBody>
                  <a:tcPr marL="7617" marR="7617" marT="761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1.1</a:t>
                      </a:r>
                    </a:p>
                  </a:txBody>
                  <a:tcPr marL="7617" marR="7617" marT="761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25</a:t>
                      </a:r>
                    </a:p>
                  </a:txBody>
                  <a:tcPr marL="7617" marR="7617" marT="761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toplasm</a:t>
                      </a:r>
                    </a:p>
                  </a:txBody>
                  <a:tcPr marL="7617" marR="7617" marT="761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</a:p>
                  </a:txBody>
                  <a:tcPr marL="7617" marR="7617" marT="7617" marB="0" anchor="ctr"/>
                </a:tc>
                <a:extLst>
                  <a:ext uri="{0D108BD9-81ED-4DB2-BD59-A6C34878D82A}">
                    <a16:rowId xmlns:a16="http://schemas.microsoft.com/office/drawing/2014/main" val="1971288578"/>
                  </a:ext>
                </a:extLst>
              </a:tr>
              <a:tr h="317499"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CKX1.B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53</a:t>
                      </a:r>
                    </a:p>
                  </a:txBody>
                  <a:tcPr marL="7617" marR="7617" marT="761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8.14</a:t>
                      </a:r>
                    </a:p>
                  </a:txBody>
                  <a:tcPr marL="7617" marR="7617" marT="761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1.1</a:t>
                      </a:r>
                    </a:p>
                  </a:txBody>
                  <a:tcPr marL="7617" marR="7617" marT="761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25</a:t>
                      </a:r>
                    </a:p>
                  </a:txBody>
                  <a:tcPr marL="7617" marR="7617" marT="761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toplasm</a:t>
                      </a:r>
                    </a:p>
                  </a:txBody>
                  <a:tcPr marL="7617" marR="7617" marT="761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</a:p>
                  </a:txBody>
                  <a:tcPr marL="7617" marR="7617" marT="7617" marB="0" anchor="ctr"/>
                </a:tc>
                <a:extLst>
                  <a:ext uri="{0D108BD9-81ED-4DB2-BD59-A6C34878D82A}">
                    <a16:rowId xmlns:a16="http://schemas.microsoft.com/office/drawing/2014/main" val="2324875483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DFCE62CA-26FF-DC36-C888-E8F0017B12E4}"/>
              </a:ext>
            </a:extLst>
          </p:cNvPr>
          <p:cNvSpPr txBox="1"/>
          <p:nvPr/>
        </p:nvSpPr>
        <p:spPr>
          <a:xfrm>
            <a:off x="504832" y="3245096"/>
            <a:ext cx="6268763" cy="2768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1</a:t>
            </a:r>
            <a:r>
              <a:rPr lang="en-I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Information of CKX protein parameters</a:t>
            </a:r>
          </a:p>
        </p:txBody>
      </p:sp>
    </p:spTree>
    <p:extLst>
      <p:ext uri="{BB962C8B-B14F-4D97-AF65-F5344CB8AC3E}">
        <p14:creationId xmlns:p14="http://schemas.microsoft.com/office/powerpoint/2010/main" val="153081268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E3C16254-04C2-BBD3-5AD3-B3B521C835E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08950303"/>
              </p:ext>
            </p:extLst>
          </p:nvPr>
        </p:nvGraphicFramePr>
        <p:xfrm>
          <a:off x="1187551" y="770164"/>
          <a:ext cx="4940426" cy="7677749"/>
        </p:xfrm>
        <a:graphic>
          <a:graphicData uri="http://schemas.openxmlformats.org/drawingml/2006/table">
            <a:tbl>
              <a:tblPr firstRow="1" bandRow="1">
                <a:tableStyleId>{21E4AEA4-8DFA-4A89-87EB-49C32662AFE0}</a:tableStyleId>
              </a:tblPr>
              <a:tblGrid>
                <a:gridCol w="1150851">
                  <a:extLst>
                    <a:ext uri="{9D8B030D-6E8A-4147-A177-3AD203B41FA5}">
                      <a16:colId xmlns:a16="http://schemas.microsoft.com/office/drawing/2014/main" val="2367951046"/>
                    </a:ext>
                  </a:extLst>
                </a:gridCol>
                <a:gridCol w="3789575">
                  <a:extLst>
                    <a:ext uri="{9D8B030D-6E8A-4147-A177-3AD203B41FA5}">
                      <a16:colId xmlns:a16="http://schemas.microsoft.com/office/drawing/2014/main" val="3226020662"/>
                    </a:ext>
                  </a:extLst>
                </a:gridCol>
              </a:tblGrid>
              <a:tr h="389080"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 ID</a:t>
                      </a:r>
                    </a:p>
                  </a:txBody>
                  <a:tcPr marL="7617" marR="7617" marT="761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quences</a:t>
                      </a:r>
                    </a:p>
                  </a:txBody>
                  <a:tcPr marL="7617" marR="7617" marT="7617" marB="0" anchor="ctr"/>
                </a:tc>
                <a:extLst>
                  <a:ext uri="{0D108BD9-81ED-4DB2-BD59-A6C34878D82A}">
                    <a16:rowId xmlns:a16="http://schemas.microsoft.com/office/drawing/2014/main" val="627698021"/>
                  </a:ext>
                </a:extLst>
              </a:tr>
              <a:tr h="330988"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IN" sz="1200" b="0" i="1" u="none" strike="noStrike" dirty="0">
                          <a:solidFill>
                            <a:sysClr val="windowText" lastClr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CKX6.A/B</a:t>
                      </a:r>
                    </a:p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ysClr val="windowText" lastClr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T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’ GTCATCAGCATGGAATCTCTCA 3’</a:t>
                      </a: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1323772546"/>
                  </a:ext>
                </a:extLst>
              </a:tr>
              <a:tr h="337921">
                <a:tc vMerge="1">
                  <a:txBody>
                    <a:bodyPr/>
                    <a:lstStyle/>
                    <a:p>
                      <a:pPr algn="l" fontAlgn="b"/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’ GTAGTCAGTCCATGATTTTGGG 3’</a:t>
                      </a: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2401070365"/>
                  </a:ext>
                </a:extLst>
              </a:tr>
              <a:tr h="330988"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IN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CKX4</a:t>
                      </a:r>
                    </a:p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ysClr val="windowText" lastClr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T</a:t>
                      </a:r>
                      <a:endParaRPr lang="en-IN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’  CTAGTATTGCTCCAAGAGGC 3’</a:t>
                      </a: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1501735269"/>
                  </a:ext>
                </a:extLst>
              </a:tr>
              <a:tr h="330988">
                <a:tc vMerge="1">
                  <a:txBody>
                    <a:bodyPr/>
                    <a:lstStyle/>
                    <a:p>
                      <a:pPr algn="ctr" fontAlgn="b"/>
                      <a:endParaRPr lang="en-IN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’  TCCAACATCAACATAAGGACC 3’</a:t>
                      </a: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2428330836"/>
                  </a:ext>
                </a:extLst>
              </a:tr>
              <a:tr h="330988"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IN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CKX1.A/B</a:t>
                      </a:r>
                    </a:p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ysClr val="windowText" lastClr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T</a:t>
                      </a:r>
                      <a:endParaRPr lang="en-IN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’  CACACCATTTCCTTCCATCA 3’</a:t>
                      </a: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3182507481"/>
                  </a:ext>
                </a:extLst>
              </a:tr>
              <a:tr h="330988">
                <a:tc vMerge="1">
                  <a:txBody>
                    <a:bodyPr/>
                    <a:lstStyle/>
                    <a:p>
                      <a:pPr algn="ctr" fontAlgn="b"/>
                      <a:endParaRPr lang="en-IN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’  GATAACCACACCTTGATGGG 3’</a:t>
                      </a: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2995549600"/>
                  </a:ext>
                </a:extLst>
              </a:tr>
              <a:tr h="330988"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IN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CKX3</a:t>
                      </a:r>
                    </a:p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ysClr val="windowText" lastClr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T</a:t>
                      </a:r>
                      <a:endParaRPr lang="en-IN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’  AACATGGCCGCTCTCAAAA 3’</a:t>
                      </a: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3853964692"/>
                  </a:ext>
                </a:extLst>
              </a:tr>
              <a:tr h="330988">
                <a:tc vMerge="1">
                  <a:txBody>
                    <a:bodyPr/>
                    <a:lstStyle/>
                    <a:p>
                      <a:pPr algn="ctr" fontAlgn="b"/>
                      <a:endParaRPr lang="en-IN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’  AGGTAGAGGTAGTCGGTCCA 3’</a:t>
                      </a: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1971288578"/>
                  </a:ext>
                </a:extLst>
              </a:tr>
              <a:tr h="330988"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IN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CKX7.A/B</a:t>
                      </a:r>
                    </a:p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ysClr val="windowText" lastClr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T</a:t>
                      </a:r>
                      <a:endParaRPr lang="en-IN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’  ACCGATTACTTAAGCCTAACTG 3’</a:t>
                      </a: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2324875483"/>
                  </a:ext>
                </a:extLst>
              </a:tr>
              <a:tr h="330988">
                <a:tc vMerge="1">
                  <a:txBody>
                    <a:bodyPr/>
                    <a:lstStyle/>
                    <a:p>
                      <a:pPr algn="ctr" fontAlgn="b"/>
                      <a:endParaRPr lang="en-IN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’  TCCGAGGACGGAGAAAAATAG 3’</a:t>
                      </a: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908680944"/>
                  </a:ext>
                </a:extLst>
              </a:tr>
              <a:tr h="330988"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IN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CKX5</a:t>
                      </a:r>
                    </a:p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ysClr val="windowText" lastClr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T</a:t>
                      </a:r>
                      <a:endParaRPr lang="en-IN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’  GTTGGCAAGGGTGAGCTC 3’</a:t>
                      </a: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3578968452"/>
                  </a:ext>
                </a:extLst>
              </a:tr>
              <a:tr h="330988">
                <a:tc vMerge="1">
                  <a:txBody>
                    <a:bodyPr/>
                    <a:lstStyle/>
                    <a:p>
                      <a:pPr algn="ctr" fontAlgn="b"/>
                      <a:endParaRPr lang="en-IN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’  TGAGGAGAAATTGGAATACAGTA 3’</a:t>
                      </a: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2867930884"/>
                  </a:ext>
                </a:extLst>
              </a:tr>
              <a:tr h="330988"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IN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CKX6.A/B </a:t>
                      </a:r>
                    </a:p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PO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’ CACCATGATCTTATTATTCCTCTTCACTTG 3’</a:t>
                      </a: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3974406170"/>
                  </a:ext>
                </a:extLst>
              </a:tr>
              <a:tr h="330988">
                <a:tc vMerge="1">
                  <a:txBody>
                    <a:bodyPr/>
                    <a:lstStyle/>
                    <a:p>
                      <a:pPr algn="ctr" fontAlgn="b"/>
                      <a:endParaRPr lang="en-IN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’ TTATGAGGAAGACAAGTGTATAATACTGTT 3’</a:t>
                      </a: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4142716931"/>
                  </a:ext>
                </a:extLst>
              </a:tr>
              <a:tr h="330988"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IN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CKX4 </a:t>
                      </a:r>
                    </a:p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PO</a:t>
                      </a:r>
                      <a:endParaRPr lang="en-IN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’ CACCATGGGTAATTTCATCCTCGTAGTAA 3’</a:t>
                      </a: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997880587"/>
                  </a:ext>
                </a:extLst>
              </a:tr>
              <a:tr h="330988">
                <a:tc vMerge="1">
                  <a:txBody>
                    <a:bodyPr/>
                    <a:lstStyle/>
                    <a:p>
                      <a:pPr algn="ctr" fontAlgn="b"/>
                      <a:endParaRPr lang="en-IN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’ CTACAAATTACTGAAAATTTTCTGTCCCG 3’</a:t>
                      </a: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2267530175"/>
                  </a:ext>
                </a:extLst>
              </a:tr>
              <a:tr h="330988"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IN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CKX3 </a:t>
                      </a:r>
                    </a:p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PO</a:t>
                      </a:r>
                      <a:endParaRPr lang="en-IN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’ CACCATGGCCGAAAATATTCTAAACGC 3’</a:t>
                      </a: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3645040432"/>
                  </a:ext>
                </a:extLst>
              </a:tr>
              <a:tr h="330988">
                <a:tc vMerge="1">
                  <a:txBody>
                    <a:bodyPr/>
                    <a:lstStyle/>
                    <a:p>
                      <a:pPr algn="ctr" fontAlgn="b"/>
                      <a:endParaRPr lang="en-IN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’ CTAGTTGAAAATTCTCTGTCCTGGTG 3’</a:t>
                      </a: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1374331103"/>
                  </a:ext>
                </a:extLst>
              </a:tr>
              <a:tr h="330988"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IN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CKX7.A/B </a:t>
                      </a:r>
                    </a:p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PO</a:t>
                      </a:r>
                      <a:endParaRPr lang="en-IN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’ CACCATGATAGCTTACCTCGGGC 3’</a:t>
                      </a: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2207026950"/>
                  </a:ext>
                </a:extLst>
              </a:tr>
              <a:tr h="330988">
                <a:tc vMerge="1">
                  <a:txBody>
                    <a:bodyPr/>
                    <a:lstStyle/>
                    <a:p>
                      <a:pPr algn="ctr" fontAlgn="b"/>
                      <a:endParaRPr lang="en-IN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’ CTAGGATTGAGGAATCCTGGAGAAA 3’</a:t>
                      </a: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3805675150"/>
                  </a:ext>
                </a:extLst>
              </a:tr>
              <a:tr h="330988"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sz="12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ACT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T</a:t>
                      </a:r>
                      <a:endParaRPr lang="en-I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’ GGCATCACTTAGCACCTTCCA 3’</a:t>
                      </a: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3419183105"/>
                  </a:ext>
                </a:extLst>
              </a:tr>
              <a:tr h="330988">
                <a:tc vMerge="1">
                  <a:txBody>
                    <a:bodyPr/>
                    <a:lstStyle/>
                    <a:p>
                      <a:pPr algn="ctr" fontAlgn="b"/>
                      <a:endParaRPr lang="en-IN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’ AATTGAAGGCCCGGACTCA 3’</a:t>
                      </a: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2393246826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39C05C15-A301-9A9A-5051-39FB72571F66}"/>
              </a:ext>
            </a:extLst>
          </p:cNvPr>
          <p:cNvSpPr txBox="1"/>
          <p:nvPr/>
        </p:nvSpPr>
        <p:spPr>
          <a:xfrm>
            <a:off x="1353798" y="493165"/>
            <a:ext cx="34827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2 </a:t>
            </a:r>
            <a:r>
              <a:rPr lang="en-I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imers in this study</a:t>
            </a:r>
          </a:p>
        </p:txBody>
      </p:sp>
    </p:spTree>
    <p:extLst>
      <p:ext uri="{BB962C8B-B14F-4D97-AF65-F5344CB8AC3E}">
        <p14:creationId xmlns:p14="http://schemas.microsoft.com/office/powerpoint/2010/main" val="9961929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8</TotalTime>
  <Words>273</Words>
  <Application>Microsoft Office PowerPoint</Application>
  <PresentationFormat>Custom</PresentationFormat>
  <Paragraphs>118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anchal singhal</dc:creator>
  <cp:lastModifiedBy>黄盼盼</cp:lastModifiedBy>
  <cp:revision>4</cp:revision>
  <dcterms:created xsi:type="dcterms:W3CDTF">2024-04-01T12:22:14Z</dcterms:created>
  <dcterms:modified xsi:type="dcterms:W3CDTF">2024-08-05T09:35:41Z</dcterms:modified>
</cp:coreProperties>
</file>